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notesMasterIdLst>
    <p:notesMasterId r:id="rId3"/>
  </p:notesMasterIdLst>
  <p:sldIdLst>
    <p:sldId id="26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stasia Lomova" initials="AL" lastIdx="1" clrIdx="0">
    <p:extLst>
      <p:ext uri="{19B8F6BF-5375-455C-9EA6-DF929625EA0E}">
        <p15:presenceInfo xmlns:p15="http://schemas.microsoft.com/office/powerpoint/2012/main" userId="8ecbc59e048ae0f3" providerId="Windows Live"/>
      </p:ext>
    </p:extLst>
  </p:cmAuthor>
  <p:cmAuthor id="2" name="Anastasia Kaufman" initials="ALK" lastIdx="18" clrIdx="1">
    <p:extLst>
      <p:ext uri="{19B8F6BF-5375-455C-9EA6-DF929625EA0E}">
        <p15:presenceInfo xmlns:p15="http://schemas.microsoft.com/office/powerpoint/2012/main" userId="Anastasia Kaufma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81" autoAdjust="0"/>
    <p:restoredTop sz="94660"/>
  </p:normalViewPr>
  <p:slideViewPr>
    <p:cSldViewPr snapToGrid="0">
      <p:cViewPr varScale="1">
        <p:scale>
          <a:sx n="55" d="100"/>
          <a:sy n="55" d="100"/>
        </p:scale>
        <p:origin x="166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IZABETH BENITEZ" userId="bfb63696475a60da" providerId="LiveId" clId="{2BF6065B-542B-4821-AF3F-B3C1CA6C4333}"/>
    <pc:docChg chg="modSld">
      <pc:chgData name="ELIZABETH BENITEZ" userId="bfb63696475a60da" providerId="LiveId" clId="{2BF6065B-542B-4821-AF3F-B3C1CA6C4333}" dt="2020-11-07T07:47:01.415" v="3" actId="20577"/>
      <pc:docMkLst>
        <pc:docMk/>
      </pc:docMkLst>
      <pc:sldChg chg="modSp mod">
        <pc:chgData name="ELIZABETH BENITEZ" userId="bfb63696475a60da" providerId="LiveId" clId="{2BF6065B-542B-4821-AF3F-B3C1CA6C4333}" dt="2020-11-07T07:47:01.415" v="3" actId="20577"/>
        <pc:sldMkLst>
          <pc:docMk/>
          <pc:sldMk cId="3328144718" sldId="268"/>
        </pc:sldMkLst>
        <pc:spChg chg="mod">
          <ac:chgData name="ELIZABETH BENITEZ" userId="bfb63696475a60da" providerId="LiveId" clId="{2BF6065B-542B-4821-AF3F-B3C1CA6C4333}" dt="2020-11-07T07:46:57.538" v="1" actId="20577"/>
          <ac:spMkLst>
            <pc:docMk/>
            <pc:sldMk cId="3328144718" sldId="268"/>
            <ac:spMk id="2" creationId="{DCB1C618-8C7A-49F4-B494-66C0FA626C5F}"/>
          </ac:spMkLst>
        </pc:spChg>
        <pc:spChg chg="mod">
          <ac:chgData name="ELIZABETH BENITEZ" userId="bfb63696475a60da" providerId="LiveId" clId="{2BF6065B-542B-4821-AF3F-B3C1CA6C4333}" dt="2020-11-07T07:47:01.415" v="3" actId="20577"/>
          <ac:spMkLst>
            <pc:docMk/>
            <pc:sldMk cId="3328144718" sldId="268"/>
            <ac:spMk id="7" creationId="{791D6526-6038-4CE6-8D40-755E193DA55D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2D9018-BECE-4694-84FF-A6A06CCCEFCB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28723C-8C9E-4E92-BC57-25165E93C1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677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0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48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86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797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187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26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774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188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3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02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755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17DF2B-8B62-49E5-9CF3-C82387B12A94}" type="datetimeFigureOut">
              <a:rPr lang="en-US" smtClean="0"/>
              <a:t>1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E344D-2B85-4160-AF19-525B692701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24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DCB1C618-8C7A-49F4-B494-66C0FA626C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733" y="359052"/>
            <a:ext cx="5094664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 – Cas9 variants tested at equal weight or equimolar amounts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125D554-3B24-4D2B-BEDA-2746FA3347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9186354"/>
              </p:ext>
            </p:extLst>
          </p:nvPr>
        </p:nvGraphicFramePr>
        <p:xfrm>
          <a:off x="515500" y="891046"/>
          <a:ext cx="5792412" cy="1607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7744707" imgH="2136880" progId="Prism8.Document">
                  <p:embed/>
                </p:oleObj>
              </mc:Choice>
              <mc:Fallback>
                <p:oleObj name="Prism 8" r:id="rId3" imgW="7744707" imgH="2136880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6125D554-3B24-4D2B-BEDA-2746FA33479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5500" y="891046"/>
                        <a:ext cx="5792412" cy="16077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91D6526-6038-4CE6-8D40-755E193DA55D}"/>
              </a:ext>
            </a:extLst>
          </p:cNvPr>
          <p:cNvSpPr txBox="1"/>
          <p:nvPr/>
        </p:nvSpPr>
        <p:spPr>
          <a:xfrm>
            <a:off x="685799" y="2586841"/>
            <a:ext cx="541421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l Figure 5. Comparison of select Cas9 variants assessed at equal weight or equimolar amounts. </a:t>
            </a:r>
          </a:p>
          <a:p>
            <a:pPr algn="just"/>
            <a:r>
              <a:rPr lang="en-US" sz="1200" dirty="0"/>
              <a:t>Comparison of CD34+ HSPC gene editing with Cas9, Cas9-hGem, Cas9-UL12, Cas9-hCtIP, and Cas9-hGem-hCtIP at equal weight (5 ug Cas9 mRNA, 5 ug IVT sgRNA) or equimolar amounts (3 </a:t>
            </a:r>
            <a:r>
              <a:rPr lang="en-US" sz="1200" dirty="0" err="1"/>
              <a:t>pmol</a:t>
            </a:r>
            <a:r>
              <a:rPr lang="en-US" sz="1200" dirty="0"/>
              <a:t> Cas9 mRNA, 120 </a:t>
            </a:r>
            <a:r>
              <a:rPr lang="en-US" sz="1200" dirty="0" err="1"/>
              <a:t>pmol</a:t>
            </a:r>
            <a:r>
              <a:rPr lang="en-US" sz="1200" dirty="0"/>
              <a:t> IVT sgRNA), with a </a:t>
            </a:r>
            <a:r>
              <a:rPr lang="en-US" sz="1200" dirty="0" err="1"/>
              <a:t>ssODN</a:t>
            </a:r>
            <a:r>
              <a:rPr lang="en-US" sz="1200" dirty="0"/>
              <a:t> donor (A), or an AAV6 donor (B). n = 2 – 4 biological replicates. Error bars, mean± SD. </a:t>
            </a:r>
          </a:p>
        </p:txBody>
      </p:sp>
    </p:spTree>
    <p:extLst>
      <p:ext uri="{BB962C8B-B14F-4D97-AF65-F5344CB8AC3E}">
        <p14:creationId xmlns:p14="http://schemas.microsoft.com/office/powerpoint/2010/main" val="3328144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01</TotalTime>
  <Words>105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</dc:creator>
  <cp:lastModifiedBy>ELIZABETH BENITEZ</cp:lastModifiedBy>
  <cp:revision>40</cp:revision>
  <dcterms:created xsi:type="dcterms:W3CDTF">2020-08-22T23:18:47Z</dcterms:created>
  <dcterms:modified xsi:type="dcterms:W3CDTF">2020-11-07T07:47:21Z</dcterms:modified>
</cp:coreProperties>
</file>